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46ADEC8-837B-4526-B2D5-2A8F9A411A58}" v="1" dt="2024-10-10T06:50:40.576"/>
    <p1510:client id="{FB9A5027-344B-42D8-9E11-C8D7D0405CB4}" v="1" dt="2024-10-10T07:12:08.47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34" autoAdjust="0"/>
    <p:restoredTop sz="94660"/>
  </p:normalViewPr>
  <p:slideViewPr>
    <p:cSldViewPr snapToGrid="0">
      <p:cViewPr varScale="1">
        <p:scale>
          <a:sx n="73" d="100"/>
          <a:sy n="73" d="100"/>
        </p:scale>
        <p:origin x="19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赤堀　ゆきこ" userId="bbfeda90-9ade-440e-995a-5a1e8cff3baf" providerId="ADAL" clId="{C46ADEC8-837B-4526-B2D5-2A8F9A411A58}"/>
    <pc:docChg chg="addSld delSld modSld">
      <pc:chgData name="赤堀　ゆきこ" userId="bbfeda90-9ade-440e-995a-5a1e8cff3baf" providerId="ADAL" clId="{C46ADEC8-837B-4526-B2D5-2A8F9A411A58}" dt="2024-10-10T07:06:01.612" v="5" actId="255"/>
      <pc:docMkLst>
        <pc:docMk/>
      </pc:docMkLst>
      <pc:sldChg chg="del">
        <pc:chgData name="赤堀　ゆきこ" userId="bbfeda90-9ade-440e-995a-5a1e8cff3baf" providerId="ADAL" clId="{C46ADEC8-837B-4526-B2D5-2A8F9A411A58}" dt="2024-10-10T06:50:42.161" v="1" actId="47"/>
        <pc:sldMkLst>
          <pc:docMk/>
          <pc:sldMk cId="2071845089" sldId="256"/>
        </pc:sldMkLst>
      </pc:sldChg>
      <pc:sldChg chg="modSp add mod">
        <pc:chgData name="赤堀　ゆきこ" userId="bbfeda90-9ade-440e-995a-5a1e8cff3baf" providerId="ADAL" clId="{C46ADEC8-837B-4526-B2D5-2A8F9A411A58}" dt="2024-10-10T07:06:01.612" v="5" actId="255"/>
        <pc:sldMkLst>
          <pc:docMk/>
          <pc:sldMk cId="1150512429" sldId="264"/>
        </pc:sldMkLst>
        <pc:spChg chg="mod">
          <ac:chgData name="赤堀　ゆきこ" userId="bbfeda90-9ade-440e-995a-5a1e8cff3baf" providerId="ADAL" clId="{C46ADEC8-837B-4526-B2D5-2A8F9A411A58}" dt="2024-10-10T07:06:01.612" v="5" actId="255"/>
          <ac:spMkLst>
            <pc:docMk/>
            <pc:sldMk cId="1150512429" sldId="264"/>
            <ac:spMk id="5" creationId="{FFDD177D-54D0-4307-F71F-74D18DBADB39}"/>
          </ac:spMkLst>
        </pc:spChg>
        <pc:graphicFrameChg chg="mod modGraphic">
          <ac:chgData name="赤堀　ゆきこ" userId="bbfeda90-9ade-440e-995a-5a1e8cff3baf" providerId="ADAL" clId="{C46ADEC8-837B-4526-B2D5-2A8F9A411A58}" dt="2024-10-10T07:05:50.053" v="4" actId="12788"/>
          <ac:graphicFrameMkLst>
            <pc:docMk/>
            <pc:sldMk cId="1150512429" sldId="264"/>
            <ac:graphicFrameMk id="4" creationId="{3B79122C-7ECE-E3E2-635A-F5E93202F8FA}"/>
          </ac:graphicFrameMkLst>
        </pc:graphicFrameChg>
      </pc:sldChg>
    </pc:docChg>
  </pc:docChgLst>
  <pc:docChgLst>
    <pc:chgData name="赤堀　ゆきこ" userId="bbfeda90-9ade-440e-995a-5a1e8cff3baf" providerId="ADAL" clId="{FB9A5027-344B-42D8-9E11-C8D7D0405CB4}"/>
    <pc:docChg chg="addSld delSld modSld">
      <pc:chgData name="赤堀　ゆきこ" userId="bbfeda90-9ade-440e-995a-5a1e8cff3baf" providerId="ADAL" clId="{FB9A5027-344B-42D8-9E11-C8D7D0405CB4}" dt="2024-10-10T07:16:36.825" v="8" actId="20577"/>
      <pc:docMkLst>
        <pc:docMk/>
      </pc:docMkLst>
      <pc:sldChg chg="modSp add mod">
        <pc:chgData name="赤堀　ゆきこ" userId="bbfeda90-9ade-440e-995a-5a1e8cff3baf" providerId="ADAL" clId="{FB9A5027-344B-42D8-9E11-C8D7D0405CB4}" dt="2024-10-10T07:16:36.825" v="8" actId="20577"/>
        <pc:sldMkLst>
          <pc:docMk/>
          <pc:sldMk cId="2888254083" sldId="258"/>
        </pc:sldMkLst>
        <pc:graphicFrameChg chg="modGraphic">
          <ac:chgData name="赤堀　ゆきこ" userId="bbfeda90-9ade-440e-995a-5a1e8cff3baf" providerId="ADAL" clId="{FB9A5027-344B-42D8-9E11-C8D7D0405CB4}" dt="2024-10-10T07:16:36.825" v="8" actId="20577"/>
          <ac:graphicFrameMkLst>
            <pc:docMk/>
            <pc:sldMk cId="2888254083" sldId="258"/>
            <ac:graphicFrameMk id="2" creationId="{37FE1CEF-CD2F-BEC5-5873-2714FEACB946}"/>
          </ac:graphicFrameMkLst>
        </pc:graphicFrameChg>
      </pc:sldChg>
      <pc:sldChg chg="del">
        <pc:chgData name="赤堀　ゆきこ" userId="bbfeda90-9ade-440e-995a-5a1e8cff3baf" providerId="ADAL" clId="{FB9A5027-344B-42D8-9E11-C8D7D0405CB4}" dt="2024-10-10T07:12:09.979" v="1" actId="47"/>
        <pc:sldMkLst>
          <pc:docMk/>
          <pc:sldMk cId="1150512429" sldId="264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26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38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706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510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6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1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3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37FE1CEF-CD2F-BEC5-5873-2714FEACB9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017015"/>
              </p:ext>
            </p:extLst>
          </p:nvPr>
        </p:nvGraphicFramePr>
        <p:xfrm>
          <a:off x="1371600" y="2770619"/>
          <a:ext cx="4114800" cy="160210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85800">
                  <a:extLst>
                    <a:ext uri="{9D8B030D-6E8A-4147-A177-3AD203B41FA5}">
                      <a16:colId xmlns:a16="http://schemas.microsoft.com/office/drawing/2014/main" val="2906514504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1931222384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62160346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738928949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534690671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683172260"/>
                    </a:ext>
                  </a:extLst>
                </a:gridCol>
              </a:tblGrid>
              <a:tr h="2476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y zone (mm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372034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3479055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7244180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173480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255859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9012123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34291240"/>
                  </a:ext>
                </a:extLst>
              </a:tr>
              <a:tr h="20002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49471197"/>
                  </a:ext>
                </a:extLst>
              </a:tr>
            </a:tbl>
          </a:graphicData>
        </a:graphic>
      </p:graphicFrame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7D2E2127-120A-33BD-D37A-D8DB5BFE7B2A}"/>
              </a:ext>
            </a:extLst>
          </p:cNvPr>
          <p:cNvGraphicFramePr>
            <a:graphicFrameLocks noGrp="1"/>
          </p:cNvGraphicFramePr>
          <p:nvPr/>
        </p:nvGraphicFramePr>
        <p:xfrm>
          <a:off x="1714500" y="4539112"/>
          <a:ext cx="3429000" cy="116205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85800">
                  <a:extLst>
                    <a:ext uri="{9D8B030D-6E8A-4147-A177-3AD203B41FA5}">
                      <a16:colId xmlns:a16="http://schemas.microsoft.com/office/drawing/2014/main" val="3694854938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717775185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3072849666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170037543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45350105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70543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9439859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66061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97711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8144823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08308281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28E4E97-A66B-2B7A-C9E1-0B34951A408F}"/>
              </a:ext>
            </a:extLst>
          </p:cNvPr>
          <p:cNvSpPr txBox="1"/>
          <p:nvPr/>
        </p:nvSpPr>
        <p:spPr>
          <a:xfrm>
            <a:off x="813777" y="2247306"/>
            <a:ext cx="22349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3 dataset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dataset of Fig. 3B and 3D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892DD1B-D812-AE58-DBF8-195B746C908D}"/>
              </a:ext>
            </a:extLst>
          </p:cNvPr>
          <p:cNvSpPr txBox="1"/>
          <p:nvPr/>
        </p:nvSpPr>
        <p:spPr>
          <a:xfrm>
            <a:off x="813777" y="1992172"/>
            <a:ext cx="1552028" cy="255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8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ja-JP" altLang="en-US" sz="105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8254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1</Words>
  <Application>Microsoft Office PowerPoint</Application>
  <PresentationFormat>A4 210 x 297 mm</PresentationFormat>
  <Paragraphs>6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赤堀　ゆきこ</dc:creator>
  <cp:lastModifiedBy>赤堀　ゆきこ</cp:lastModifiedBy>
  <cp:revision>4</cp:revision>
  <dcterms:created xsi:type="dcterms:W3CDTF">2024-10-10T06:46:11Z</dcterms:created>
  <dcterms:modified xsi:type="dcterms:W3CDTF">2024-10-10T07:16:37Z</dcterms:modified>
</cp:coreProperties>
</file>